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000000"/>
                </a:solidFill>
                <a:latin typeface="Calibri"/>
                <a:ea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  <a:ea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43080" y="685440"/>
            <a:ext cx="257184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000000"/>
                </a:solidFill>
                <a:latin typeface="Calibri"/>
                <a:ea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D716EB3-A9CC-4CF5-8486-EFECBE5394A5}" type="slidenum">
              <a:rPr b="0" lang="en-GB" sz="1200" spc="-1" strike="noStrike">
                <a:solidFill>
                  <a:srgbClr val="000000"/>
                </a:solidFill>
                <a:latin typeface="Calibri"/>
                <a:ea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62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B809152-2598-4274-A953-1A016A8B3B34}" type="slidenum">
              <a:rPr b="0" lang="en-GB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7BA3DD-5DC7-44E3-A16A-1E61A18C341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AF6944-FDE8-4839-A33A-AF81A897141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DE252B-0C57-4372-9DB8-B5F3905898A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4CD913-ADD5-4905-995C-B60B85E8074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E49C37-BAA4-436B-8B27-6F527B1D057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62E383-A75D-4D61-92CD-B1759B1E202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32B668-192D-4CB6-9408-320D6A87A2C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C11B14-C8D0-4687-923A-279B1063A00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DB1822-0F69-46B4-93D5-F93A21AC4D3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EFC3E0-3291-4493-B707-C5CA67AE314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2B55D1-306E-4309-AF2A-C75D6FD8ACE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AE6843-A676-43B6-ACCC-05DF759D73C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  <a:ea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  <a:ea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  <a:ea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4A3DDF2-AFB0-4143-8F7F-534022586CA2}" type="slidenum">
              <a:rPr b="0" lang="en-GB" sz="1200" spc="-1" strike="noStrike">
                <a:solidFill>
                  <a:srgbClr val="898989"/>
                </a:solidFill>
                <a:latin typeface="Calibri"/>
                <a:ea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Box 1"/>
          <p:cNvSpPr/>
          <p:nvPr/>
        </p:nvSpPr>
        <p:spPr>
          <a:xfrm>
            <a:off x="4943160" y="8793000"/>
            <a:ext cx="1915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S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CaixaDeTexto 10"/>
          <p:cNvSpPr/>
          <p:nvPr/>
        </p:nvSpPr>
        <p:spPr>
          <a:xfrm>
            <a:off x="2482920" y="2371680"/>
            <a:ext cx="865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Arial"/>
              </a:rPr>
              <a:t>MCF-7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CaixaDeTexto 11"/>
          <p:cNvSpPr/>
          <p:nvPr/>
        </p:nvSpPr>
        <p:spPr>
          <a:xfrm>
            <a:off x="3809880" y="4443480"/>
            <a:ext cx="1333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Arial"/>
              </a:rPr>
              <a:t>MCF-7Epi</a:t>
            </a:r>
            <a:r>
              <a:rPr b="0" lang="pt-BR" sz="1200" spc="-1" strike="noStrike" baseline="30000">
                <a:solidFill>
                  <a:srgbClr val="000000"/>
                </a:solidFill>
                <a:latin typeface="Arial"/>
              </a:rPr>
              <a:t>R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1" name="Chart 39" descr=""/>
          <p:cNvPicPr/>
          <p:nvPr/>
        </p:nvPicPr>
        <p:blipFill>
          <a:blip r:embed="rId1"/>
          <a:stretch/>
        </p:blipFill>
        <p:spPr>
          <a:xfrm>
            <a:off x="2054160" y="2462040"/>
            <a:ext cx="3187800" cy="1609920"/>
          </a:xfrm>
          <a:prstGeom prst="rect">
            <a:avLst/>
          </a:prstGeom>
          <a:ln w="0">
            <a:noFill/>
          </a:ln>
        </p:spPr>
      </p:pic>
      <p:pic>
        <p:nvPicPr>
          <p:cNvPr id="52" name="Chart 40" descr=""/>
          <p:cNvPicPr/>
          <p:nvPr/>
        </p:nvPicPr>
        <p:blipFill>
          <a:blip r:embed="rId2"/>
          <a:stretch/>
        </p:blipFill>
        <p:spPr>
          <a:xfrm>
            <a:off x="2077920" y="4552920"/>
            <a:ext cx="3164040" cy="1562040"/>
          </a:xfrm>
          <a:prstGeom prst="rect">
            <a:avLst/>
          </a:prstGeom>
          <a:ln w="0">
            <a:noFill/>
          </a:ln>
        </p:spPr>
      </p:pic>
      <p:sp>
        <p:nvSpPr>
          <p:cNvPr id="53" name="CaixaDeTexto 10"/>
          <p:cNvSpPr/>
          <p:nvPr/>
        </p:nvSpPr>
        <p:spPr>
          <a:xfrm>
            <a:off x="2449440" y="4429080"/>
            <a:ext cx="865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Arial"/>
              </a:rPr>
              <a:t>MCF-7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CaixaDeTexto 11"/>
          <p:cNvSpPr/>
          <p:nvPr/>
        </p:nvSpPr>
        <p:spPr>
          <a:xfrm>
            <a:off x="3767040" y="2368440"/>
            <a:ext cx="1333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Arial"/>
              </a:rPr>
              <a:t>MCF-7Tax</a:t>
            </a:r>
            <a:r>
              <a:rPr b="0" lang="pt-BR" sz="1200" spc="-1" strike="noStrike" baseline="30000">
                <a:solidFill>
                  <a:srgbClr val="000000"/>
                </a:solidFill>
                <a:latin typeface="Arial"/>
              </a:rPr>
              <a:t>R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TextBox 9"/>
          <p:cNvSpPr/>
          <p:nvPr/>
        </p:nvSpPr>
        <p:spPr>
          <a:xfrm>
            <a:off x="1475280" y="3765600"/>
            <a:ext cx="9198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Paclitaxel: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(10 nM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TextBox 10"/>
          <p:cNvSpPr/>
          <p:nvPr/>
        </p:nvSpPr>
        <p:spPr>
          <a:xfrm rot="16200000">
            <a:off x="1038960" y="2824200"/>
            <a:ext cx="14958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Normalised FOXK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level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TextBox 9"/>
          <p:cNvSpPr/>
          <p:nvPr/>
        </p:nvSpPr>
        <p:spPr>
          <a:xfrm>
            <a:off x="1456560" y="5796000"/>
            <a:ext cx="9367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Epirubicin: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(1 µM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TextBox 10"/>
          <p:cNvSpPr/>
          <p:nvPr/>
        </p:nvSpPr>
        <p:spPr>
          <a:xfrm rot="16200000">
            <a:off x="1053360" y="4904640"/>
            <a:ext cx="14958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Normalised FOXK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level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TextBox 1"/>
          <p:cNvSpPr/>
          <p:nvPr/>
        </p:nvSpPr>
        <p:spPr>
          <a:xfrm>
            <a:off x="5001120" y="380988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h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TextBox 49"/>
          <p:cNvSpPr/>
          <p:nvPr/>
        </p:nvSpPr>
        <p:spPr>
          <a:xfrm>
            <a:off x="5004360" y="583236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h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89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1-12T14:16:50Z</dcterms:created>
  <dc:creator>gn912</dc:creator>
  <dc:description/>
  <dc:language>en-US</dc:language>
  <cp:lastModifiedBy>Eric Lam</cp:lastModifiedBy>
  <dcterms:modified xsi:type="dcterms:W3CDTF">2015-07-22T14:24:54Z</dcterms:modified>
  <cp:revision>208</cp:revision>
  <dc:subject/>
  <dc:title>PowerPoint Presentation</dc:title>
</cp:coreProperties>
</file>